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1" r:id="rId3"/>
    <p:sldId id="262" r:id="rId4"/>
  </p:sldIdLst>
  <p:sldSz cx="6858000" cy="9144000" type="screen4x3"/>
  <p:notesSz cx="67833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9" userDrawn="1">
          <p15:clr>
            <a:srgbClr val="A4A3A4"/>
          </p15:clr>
        </p15:guide>
        <p15:guide id="2" pos="256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o Bauer" initials="MB" lastIdx="1" clrIdx="0">
    <p:extLst>
      <p:ext uri="{19B8F6BF-5375-455C-9EA6-DF929625EA0E}">
        <p15:presenceInfo xmlns:p15="http://schemas.microsoft.com/office/powerpoint/2012/main" userId="S-1-5-21-579908582-3987748265-4076907119-272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5" d="100"/>
          <a:sy n="95" d="100"/>
        </p:scale>
        <p:origin x="2100" y="78"/>
      </p:cViewPr>
      <p:guideLst>
        <p:guide orient="horz" pos="1519"/>
        <p:guide pos="25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398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1691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1101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2960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7332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4814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0617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2081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8783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8428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4160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D4E8E-46C0-49B3-BE5E-3AC1A3B6F368}" type="datetimeFigureOut">
              <a:rPr lang="de-DE" smtClean="0"/>
              <a:t>18.07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38AD2-8B04-4225-9232-BF2DDF1F183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5543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18" name="Rectangle 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2" name="Rechteck 1"/>
          <p:cNvSpPr/>
          <p:nvPr/>
        </p:nvSpPr>
        <p:spPr>
          <a:xfrm>
            <a:off x="339130" y="2677999"/>
            <a:ext cx="611420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. </a:t>
            </a:r>
            <a:r>
              <a:rPr lang="en-US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perimental procedure. </a:t>
            </a:r>
            <a:r>
              <a:rPr lang="en-US" sz="10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lb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/c mice (dams) were exposed starting one week before mating until weaning of the pups at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eks.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offspring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ody weight was monitored and ITT was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ssessed in week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, GTT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week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0,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whole body 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mposition (</a:t>
            </a:r>
            <a:r>
              <a:rPr lang="en-US" sz="1000" dirty="0" err="1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choMRI</a:t>
            </a:r>
            <a:r>
              <a:rPr lang="en-US" sz="10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in week 12.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irect after weaning and 12 weeks after birth gene expression analysis was be performed in the F1 generation. </a:t>
            </a:r>
            <a:endParaRPr lang="en-US" sz="1000" dirty="0" smtClean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130" y="325147"/>
            <a:ext cx="3855555" cy="2086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50663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18" name="Rectangle 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355" y="683568"/>
            <a:ext cx="1919517" cy="1726144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339130" y="2677999"/>
            <a:ext cx="611420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</a:t>
            </a:r>
            <a:r>
              <a:rPr lang="en-GB" sz="10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. </a:t>
            </a: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ternal BDE-47 exposure and serum leptin levels in male offspring.</a:t>
            </a:r>
            <a:endParaRPr lang="de-DE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vels of leptin in serum of male offspring. Data are expressed as mean ± SEM, n ≥ 8. </a:t>
            </a:r>
            <a:endParaRPr lang="de-DE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3389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2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18" name="Rectangle 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sp>
        <p:nvSpPr>
          <p:cNvPr id="8" name="Textfeld 7"/>
          <p:cNvSpPr txBox="1"/>
          <p:nvPr/>
        </p:nvSpPr>
        <p:spPr>
          <a:xfrm>
            <a:off x="234007" y="5198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556156" y="51980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611814" y="539552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Fat</a:t>
            </a:r>
            <a:endParaRPr lang="de-DE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924182" y="53955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1268760" y="683568"/>
            <a:ext cx="12747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i="1" dirty="0">
                <a:latin typeface="Arial" panose="020B0604020202020204" pitchFamily="34" charset="0"/>
                <a:cs typeface="Arial" panose="020B0604020202020204" pitchFamily="34" charset="0"/>
              </a:rPr>
              <a:t>4-weeks </a:t>
            </a:r>
            <a:r>
              <a:rPr lang="de-DE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de-DE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offspring</a:t>
            </a:r>
            <a:endParaRPr lang="de-DE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539264" y="683568"/>
            <a:ext cx="12747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i="1" dirty="0">
                <a:latin typeface="Arial" panose="020B0604020202020204" pitchFamily="34" charset="0"/>
                <a:cs typeface="Arial" panose="020B0604020202020204" pitchFamily="34" charset="0"/>
              </a:rPr>
              <a:t>4-weeks </a:t>
            </a:r>
            <a:r>
              <a:rPr lang="de-DE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de-DE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offspring</a:t>
            </a:r>
            <a:endParaRPr lang="de-DE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656" y="827584"/>
            <a:ext cx="3019240" cy="2066041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404664" y="5572561"/>
            <a:ext cx="62596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</a:t>
            </a:r>
            <a:r>
              <a:rPr lang="en-GB" sz="10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. </a:t>
            </a: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ternal BDE-47 exposure and expression of key genes in the </a:t>
            </a:r>
            <a:r>
              <a:rPr lang="en-GB" sz="10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-weeks-old female </a:t>
            </a:r>
            <a:r>
              <a:rPr lang="en-GB" sz="10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fspring.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mRNA expression levels of selected target genes investigated in (A) adipose tissue and (B) liver of 4-weeks-old female offspring. Data are expressed as mean ± SEM, n ≥ 3. 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8683" y="809583"/>
            <a:ext cx="2732645" cy="2066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18761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Bildschirmpräsentation (4:3)</PresentationFormat>
  <Paragraphs>11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Larissa</vt:lpstr>
      <vt:lpstr>PowerPoint-Präsentation</vt:lpstr>
      <vt:lpstr>PowerPoint-Präsentation</vt:lpstr>
      <vt:lpstr>PowerPoint-Präsentation</vt:lpstr>
    </vt:vector>
  </TitlesOfParts>
  <Company>UFZ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obias Polte polte</dc:creator>
  <cp:lastModifiedBy>Tobias Polte polte</cp:lastModifiedBy>
  <cp:revision>62</cp:revision>
  <cp:lastPrinted>2024-05-23T11:43:52Z</cp:lastPrinted>
  <dcterms:created xsi:type="dcterms:W3CDTF">2017-11-20T09:00:42Z</dcterms:created>
  <dcterms:modified xsi:type="dcterms:W3CDTF">2024-07-18T11:16:12Z</dcterms:modified>
</cp:coreProperties>
</file>